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8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2" d="100"/>
          <a:sy n="82" d="100"/>
        </p:scale>
        <p:origin x="3042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E01EE-5CD9-4274-ADDC-18F41618C8A9}" type="datetimeFigureOut">
              <a:rPr kumimoji="1" lang="ja-JP" altLang="en-US" smtClean="0"/>
              <a:t>2020/9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F1C7C-BBD4-42E1-85C2-AF0A6DD095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731061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E01EE-5CD9-4274-ADDC-18F41618C8A9}" type="datetimeFigureOut">
              <a:rPr kumimoji="1" lang="ja-JP" altLang="en-US" smtClean="0"/>
              <a:t>2020/9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F1C7C-BBD4-42E1-85C2-AF0A6DD095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49037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E01EE-5CD9-4274-ADDC-18F41618C8A9}" type="datetimeFigureOut">
              <a:rPr kumimoji="1" lang="ja-JP" altLang="en-US" smtClean="0"/>
              <a:t>2020/9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F1C7C-BBD4-42E1-85C2-AF0A6DD095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762994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E01EE-5CD9-4274-ADDC-18F41618C8A9}" type="datetimeFigureOut">
              <a:rPr kumimoji="1" lang="ja-JP" altLang="en-US" smtClean="0"/>
              <a:t>2020/9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F1C7C-BBD4-42E1-85C2-AF0A6DD095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44623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E01EE-5CD9-4274-ADDC-18F41618C8A9}" type="datetimeFigureOut">
              <a:rPr kumimoji="1" lang="ja-JP" altLang="en-US" smtClean="0"/>
              <a:t>2020/9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F1C7C-BBD4-42E1-85C2-AF0A6DD095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255459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E01EE-5CD9-4274-ADDC-18F41618C8A9}" type="datetimeFigureOut">
              <a:rPr kumimoji="1" lang="ja-JP" altLang="en-US" smtClean="0"/>
              <a:t>2020/9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F1C7C-BBD4-42E1-85C2-AF0A6DD095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62884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E01EE-5CD9-4274-ADDC-18F41618C8A9}" type="datetimeFigureOut">
              <a:rPr kumimoji="1" lang="ja-JP" altLang="en-US" smtClean="0"/>
              <a:t>2020/9/2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F1C7C-BBD4-42E1-85C2-AF0A6DD095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723217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E01EE-5CD9-4274-ADDC-18F41618C8A9}" type="datetimeFigureOut">
              <a:rPr kumimoji="1" lang="ja-JP" altLang="en-US" smtClean="0"/>
              <a:t>2020/9/2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F1C7C-BBD4-42E1-85C2-AF0A6DD095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204676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E01EE-5CD9-4274-ADDC-18F41618C8A9}" type="datetimeFigureOut">
              <a:rPr kumimoji="1" lang="ja-JP" altLang="en-US" smtClean="0"/>
              <a:t>2020/9/2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F1C7C-BBD4-42E1-85C2-AF0A6DD095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212323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E01EE-5CD9-4274-ADDC-18F41618C8A9}" type="datetimeFigureOut">
              <a:rPr kumimoji="1" lang="ja-JP" altLang="en-US" smtClean="0"/>
              <a:t>2020/9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F1C7C-BBD4-42E1-85C2-AF0A6DD095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46865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E01EE-5CD9-4274-ADDC-18F41618C8A9}" type="datetimeFigureOut">
              <a:rPr kumimoji="1" lang="ja-JP" altLang="en-US" smtClean="0"/>
              <a:t>2020/9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2F1C7C-BBD4-42E1-85C2-AF0A6DD095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941994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0E01EE-5CD9-4274-ADDC-18F41618C8A9}" type="datetimeFigureOut">
              <a:rPr kumimoji="1" lang="ja-JP" altLang="en-US" smtClean="0"/>
              <a:t>2020/9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2F1C7C-BBD4-42E1-85C2-AF0A6DD095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83102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6AEDC7A0-63BE-4F09-810A-CBC83406BEBC}"/>
              </a:ext>
            </a:extLst>
          </p:cNvPr>
          <p:cNvSpPr txBox="1"/>
          <p:nvPr/>
        </p:nvSpPr>
        <p:spPr>
          <a:xfrm>
            <a:off x="0" y="2053862"/>
            <a:ext cx="68580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sFigure7. 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Multivariate cox hazard proportional analysis cancer-specific analysis of the CRC patients.</a:t>
            </a:r>
          </a:p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We performed multivariate Cox regression analysis to compute a HR according to age ≥ 70, male sex, depth of invasion (pT4), the presence of LN metastasis, low hemoglobin, GPS 1-2, NLR (≥ 5), PLR (≥150</a:t>
            </a:r>
            <a:r>
              <a:rPr kumimoji="1"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) and 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low transferrin by using method “enter”.</a:t>
            </a: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42C745B6-D856-4D44-BBB6-77C7CDBFA01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6858000" cy="20381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348653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</TotalTime>
  <Words>71</Words>
  <Application>Microsoft Office PowerPoint</Application>
  <PresentationFormat>A4 210 x 297 mm</PresentationFormat>
  <Paragraphs>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澤山 浩</dc:creator>
  <cp:lastModifiedBy>澤山 浩</cp:lastModifiedBy>
  <cp:revision>11</cp:revision>
  <dcterms:created xsi:type="dcterms:W3CDTF">2020-05-05T12:02:23Z</dcterms:created>
  <dcterms:modified xsi:type="dcterms:W3CDTF">2020-09-27T10:43:01Z</dcterms:modified>
</cp:coreProperties>
</file>